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jpeg" ContentType="image/jpeg"/>
  <Override PartName="/ppt/media/image11.jpeg" ContentType="image/jpeg"/>
  <Override PartName="/ppt/media/image13.jpeg" ContentType="image/jpeg"/>
  <Override PartName="/ppt/media/image16.jpeg" ContentType="image/jpeg"/>
  <Override PartName="/ppt/media/image15.jpeg" ContentType="image/jpeg"/>
  <Override PartName="/ppt/media/image14.jpeg" ContentType="image/jpeg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media/image7.jpeg" ContentType="image/jpeg"/>
  <Override PartName="/ppt/media/image12.jpeg" ContentType="image/jpeg"/>
  <Override PartName="/ppt/media/image10.jpeg" ContentType="image/jpeg"/>
  <Override PartName="/ppt/media/image8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6D5EBF-2C2F-4E26-BD9F-4B551F63C7E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874AC2-BDFA-4E09-AA3F-D461B396B39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49F397-6E65-4481-BD48-653188E3C5F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6A5275-EE7D-4647-BC8D-FCF9513DAB5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757228-A824-421C-B0E1-1D22E977E5D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8ADAA6-4C97-4E0B-B24D-085EB6E5A42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C1E6AD-AF2A-4C14-9C25-3C8398C87FA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1B9D75-AE2F-46B8-934E-67D1C458284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BC50E3-7E60-4769-9D49-15BF42E1FDA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48D556-023D-46D4-A62C-0BF1C2E211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65D7DE-B022-4545-BEA6-AC4022D2D34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6473F6-8CD4-48DC-A87A-F6343105B6A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85B9252-F781-4CF6-9F82-1B8E0E65D663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6.jpeg"/><Relationship Id="rId2" Type="http://schemas.openxmlformats.org/officeDocument/2006/relationships/image" Target="../media/image7.jpeg"/><Relationship Id="rId3" Type="http://schemas.openxmlformats.org/officeDocument/2006/relationships/image" Target="../media/image8.jpeg"/><Relationship Id="rId4" Type="http://schemas.openxmlformats.org/officeDocument/2006/relationships/image" Target="../media/image9.jpeg"/><Relationship Id="rId5" Type="http://schemas.openxmlformats.org/officeDocument/2006/relationships/image" Target="../media/image10.jpeg"/><Relationship Id="rId6" Type="http://schemas.openxmlformats.org/officeDocument/2006/relationships/image" Target="../media/image11.jpeg"/><Relationship Id="rId7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2.jpeg"/><Relationship Id="rId2" Type="http://schemas.openxmlformats.org/officeDocument/2006/relationships/image" Target="../media/image13.jpeg"/><Relationship Id="rId3" Type="http://schemas.openxmlformats.org/officeDocument/2006/relationships/image" Target="../media/image14.jpeg"/><Relationship Id="rId4" Type="http://schemas.openxmlformats.org/officeDocument/2006/relationships/image" Target="../media/image15.jpeg"/><Relationship Id="rId5" Type="http://schemas.openxmlformats.org/officeDocument/2006/relationships/image" Target="../media/image16.jpe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3"/>
          <p:cNvSpPr/>
          <p:nvPr/>
        </p:nvSpPr>
        <p:spPr>
          <a:xfrm>
            <a:off x="81000" y="85680"/>
            <a:ext cx="2014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Supplementary Informat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Rectangle 4"/>
          <p:cNvSpPr/>
          <p:nvPr/>
        </p:nvSpPr>
        <p:spPr>
          <a:xfrm>
            <a:off x="65160" y="436680"/>
            <a:ext cx="5643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Figure 3.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(C) Representative original western blot images investigating Nrf2 and HO-1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3" name="Group 9"/>
          <p:cNvGrpSpPr/>
          <p:nvPr/>
        </p:nvGrpSpPr>
        <p:grpSpPr>
          <a:xfrm>
            <a:off x="1695600" y="712800"/>
            <a:ext cx="9161280" cy="2394000"/>
            <a:chOff x="1695600" y="712800"/>
            <a:chExt cx="9161280" cy="2394000"/>
          </a:xfrm>
        </p:grpSpPr>
        <p:pic>
          <p:nvPicPr>
            <p:cNvPr id="44" name="Picture 5" descr=""/>
            <p:cNvPicPr/>
            <p:nvPr/>
          </p:nvPicPr>
          <p:blipFill>
            <a:blip r:embed="rId1"/>
            <a:stretch/>
          </p:blipFill>
          <p:spPr>
            <a:xfrm>
              <a:off x="1900800" y="890280"/>
              <a:ext cx="3459240" cy="2102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Picture 6" descr=""/>
            <p:cNvPicPr/>
            <p:nvPr/>
          </p:nvPicPr>
          <p:blipFill>
            <a:blip r:embed="rId2"/>
            <a:stretch/>
          </p:blipFill>
          <p:spPr>
            <a:xfrm>
              <a:off x="4518000" y="712800"/>
              <a:ext cx="3378600" cy="2394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Picture 7" descr=""/>
            <p:cNvPicPr/>
            <p:nvPr/>
          </p:nvPicPr>
          <p:blipFill>
            <a:blip r:embed="rId3"/>
            <a:stretch/>
          </p:blipFill>
          <p:spPr>
            <a:xfrm>
              <a:off x="7025760" y="793440"/>
              <a:ext cx="3831120" cy="2125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7" name="TextBox 8"/>
            <p:cNvSpPr/>
            <p:nvPr/>
          </p:nvSpPr>
          <p:spPr>
            <a:xfrm>
              <a:off x="1695600" y="1745280"/>
              <a:ext cx="637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rf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TextBox 11"/>
            <p:cNvSpPr/>
            <p:nvPr/>
          </p:nvSpPr>
          <p:spPr>
            <a:xfrm>
              <a:off x="4424760" y="1749960"/>
              <a:ext cx="637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O-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TextBox 12"/>
            <p:cNvSpPr/>
            <p:nvPr/>
          </p:nvSpPr>
          <p:spPr>
            <a:xfrm>
              <a:off x="7015320" y="1745280"/>
              <a:ext cx="637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β-actin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文本框 7"/>
            <p:cNvSpPr/>
            <p:nvPr/>
          </p:nvSpPr>
          <p:spPr>
            <a:xfrm rot="19380000">
              <a:off x="2997360" y="1514880"/>
              <a:ext cx="636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Control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文本框 8"/>
            <p:cNvSpPr/>
            <p:nvPr/>
          </p:nvSpPr>
          <p:spPr>
            <a:xfrm rot="19380000">
              <a:off x="3348720" y="1620000"/>
              <a:ext cx="412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LP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文本框 9"/>
            <p:cNvSpPr/>
            <p:nvPr/>
          </p:nvSpPr>
          <p:spPr>
            <a:xfrm rot="19380000">
              <a:off x="3651120" y="1581840"/>
              <a:ext cx="538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Allici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文本框 7"/>
            <p:cNvSpPr/>
            <p:nvPr/>
          </p:nvSpPr>
          <p:spPr>
            <a:xfrm rot="19380000">
              <a:off x="5606640" y="1417680"/>
              <a:ext cx="636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Control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文本框 8"/>
            <p:cNvSpPr/>
            <p:nvPr/>
          </p:nvSpPr>
          <p:spPr>
            <a:xfrm rot="19380000">
              <a:off x="5930280" y="1523160"/>
              <a:ext cx="412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LP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文本框 9"/>
            <p:cNvSpPr/>
            <p:nvPr/>
          </p:nvSpPr>
          <p:spPr>
            <a:xfrm rot="19380000">
              <a:off x="6149520" y="1485000"/>
              <a:ext cx="538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Allici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文本框 7"/>
            <p:cNvSpPr/>
            <p:nvPr/>
          </p:nvSpPr>
          <p:spPr>
            <a:xfrm rot="19380000">
              <a:off x="9088920" y="1389960"/>
              <a:ext cx="636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Control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文本框 8"/>
            <p:cNvSpPr/>
            <p:nvPr/>
          </p:nvSpPr>
          <p:spPr>
            <a:xfrm rot="19380000">
              <a:off x="9402840" y="1495440"/>
              <a:ext cx="412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LP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文本框 9"/>
            <p:cNvSpPr/>
            <p:nvPr/>
          </p:nvSpPr>
          <p:spPr>
            <a:xfrm rot="19380000">
              <a:off x="9659160" y="1457280"/>
              <a:ext cx="538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Allici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9" name="Rectangle 23"/>
          <p:cNvSpPr/>
          <p:nvPr/>
        </p:nvSpPr>
        <p:spPr>
          <a:xfrm>
            <a:off x="135000" y="3270240"/>
            <a:ext cx="5951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Figure 3.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(F) Representative original western blot images investigating nuclear Nrf2 protein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0" name="Group 24"/>
          <p:cNvGrpSpPr/>
          <p:nvPr/>
        </p:nvGrpSpPr>
        <p:grpSpPr>
          <a:xfrm>
            <a:off x="1195560" y="3703680"/>
            <a:ext cx="7346880" cy="2654280"/>
            <a:chOff x="1195560" y="3703680"/>
            <a:chExt cx="7346880" cy="2654280"/>
          </a:xfrm>
        </p:grpSpPr>
        <p:pic>
          <p:nvPicPr>
            <p:cNvPr id="61" name="Picture 10" descr=""/>
            <p:cNvPicPr/>
            <p:nvPr/>
          </p:nvPicPr>
          <p:blipFill>
            <a:blip r:embed="rId4"/>
            <a:stretch/>
          </p:blipFill>
          <p:spPr>
            <a:xfrm>
              <a:off x="1977480" y="3703680"/>
              <a:ext cx="3268440" cy="2517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2" name="Picture 22" descr=""/>
            <p:cNvPicPr/>
            <p:nvPr/>
          </p:nvPicPr>
          <p:blipFill>
            <a:blip r:embed="rId5"/>
            <a:stretch/>
          </p:blipFill>
          <p:spPr>
            <a:xfrm>
              <a:off x="5164200" y="3884040"/>
              <a:ext cx="3378240" cy="2473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3" name="TextBox 26"/>
            <p:cNvSpPr/>
            <p:nvPr/>
          </p:nvSpPr>
          <p:spPr>
            <a:xfrm>
              <a:off x="1195560" y="4817160"/>
              <a:ext cx="1129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uclear Nrf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TextBox 27"/>
            <p:cNvSpPr/>
            <p:nvPr/>
          </p:nvSpPr>
          <p:spPr>
            <a:xfrm>
              <a:off x="5237640" y="4812480"/>
              <a:ext cx="848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Lamin B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文本框 7"/>
            <p:cNvSpPr/>
            <p:nvPr/>
          </p:nvSpPr>
          <p:spPr>
            <a:xfrm rot="19380000">
              <a:off x="2992680" y="4586400"/>
              <a:ext cx="636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Control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文本框 8"/>
            <p:cNvSpPr/>
            <p:nvPr/>
          </p:nvSpPr>
          <p:spPr>
            <a:xfrm rot="19380000">
              <a:off x="3343320" y="4691880"/>
              <a:ext cx="412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LP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文本框 9"/>
            <p:cNvSpPr/>
            <p:nvPr/>
          </p:nvSpPr>
          <p:spPr>
            <a:xfrm rot="19380000">
              <a:off x="3646080" y="4653720"/>
              <a:ext cx="538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Allici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文本框 7"/>
            <p:cNvSpPr/>
            <p:nvPr/>
          </p:nvSpPr>
          <p:spPr>
            <a:xfrm rot="19380000">
              <a:off x="6612840" y="4512600"/>
              <a:ext cx="636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Control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文本框 8"/>
            <p:cNvSpPr/>
            <p:nvPr/>
          </p:nvSpPr>
          <p:spPr>
            <a:xfrm rot="19380000">
              <a:off x="6935760" y="4617720"/>
              <a:ext cx="412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LP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文本框 9"/>
            <p:cNvSpPr/>
            <p:nvPr/>
          </p:nvSpPr>
          <p:spPr>
            <a:xfrm rot="19380000">
              <a:off x="7220160" y="4579560"/>
              <a:ext cx="538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Allici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Rectangle 3"/>
          <p:cNvSpPr/>
          <p:nvPr/>
        </p:nvSpPr>
        <p:spPr>
          <a:xfrm>
            <a:off x="81000" y="85680"/>
            <a:ext cx="2014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Supplementary Informat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Rectangle 4"/>
          <p:cNvSpPr/>
          <p:nvPr/>
        </p:nvSpPr>
        <p:spPr>
          <a:xfrm>
            <a:off x="65160" y="436680"/>
            <a:ext cx="6686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Figure 4.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(A)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presentative original western blot bands investigating NLRP3 pathway proteins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3" name="Group 61"/>
          <p:cNvGrpSpPr/>
          <p:nvPr/>
        </p:nvGrpSpPr>
        <p:grpSpPr>
          <a:xfrm>
            <a:off x="1244520" y="787320"/>
            <a:ext cx="9472680" cy="4764240"/>
            <a:chOff x="1244520" y="787320"/>
            <a:chExt cx="9472680" cy="4764240"/>
          </a:xfrm>
        </p:grpSpPr>
        <p:pic>
          <p:nvPicPr>
            <p:cNvPr id="74" name="Picture 1" descr=""/>
            <p:cNvPicPr/>
            <p:nvPr/>
          </p:nvPicPr>
          <p:blipFill>
            <a:blip r:embed="rId1"/>
            <a:stretch/>
          </p:blipFill>
          <p:spPr>
            <a:xfrm>
              <a:off x="1361520" y="974880"/>
              <a:ext cx="3317400" cy="2118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5" name="TextBox 34"/>
            <p:cNvSpPr/>
            <p:nvPr/>
          </p:nvSpPr>
          <p:spPr>
            <a:xfrm>
              <a:off x="1244520" y="1833120"/>
              <a:ext cx="771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ro-IL-</a:t>
              </a:r>
              <a:r>
                <a:rPr b="1" lang="el-G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β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76" name="Picture 2" descr=""/>
            <p:cNvPicPr/>
            <p:nvPr/>
          </p:nvPicPr>
          <p:blipFill>
            <a:blip r:embed="rId2"/>
            <a:stretch/>
          </p:blipFill>
          <p:spPr>
            <a:xfrm>
              <a:off x="4707000" y="787320"/>
              <a:ext cx="3146760" cy="2621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7" name="TextBox 35"/>
            <p:cNvSpPr/>
            <p:nvPr/>
          </p:nvSpPr>
          <p:spPr>
            <a:xfrm>
              <a:off x="4259880" y="1828440"/>
              <a:ext cx="1115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ro-caspase-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78" name="Picture 25" descr=""/>
            <p:cNvPicPr/>
            <p:nvPr/>
          </p:nvPicPr>
          <p:blipFill>
            <a:blip r:embed="rId3"/>
            <a:stretch/>
          </p:blipFill>
          <p:spPr>
            <a:xfrm>
              <a:off x="7451280" y="1182960"/>
              <a:ext cx="2865600" cy="1791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9" name="TextBox 36"/>
            <p:cNvSpPr/>
            <p:nvPr/>
          </p:nvSpPr>
          <p:spPr>
            <a:xfrm>
              <a:off x="7162560" y="1828440"/>
              <a:ext cx="526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-1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80" name="Picture 37" descr=""/>
            <p:cNvPicPr/>
            <p:nvPr/>
          </p:nvPicPr>
          <p:blipFill>
            <a:blip r:embed="rId4"/>
            <a:stretch/>
          </p:blipFill>
          <p:spPr>
            <a:xfrm>
              <a:off x="1694160" y="3424320"/>
              <a:ext cx="3228480" cy="1914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1" name="TextBox 38"/>
            <p:cNvSpPr/>
            <p:nvPr/>
          </p:nvSpPr>
          <p:spPr>
            <a:xfrm>
              <a:off x="1302480" y="4239720"/>
              <a:ext cx="701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LRP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82" name="Picture 39" descr=""/>
            <p:cNvPicPr/>
            <p:nvPr/>
          </p:nvPicPr>
          <p:blipFill>
            <a:blip r:embed="rId5"/>
            <a:stretch/>
          </p:blipFill>
          <p:spPr>
            <a:xfrm>
              <a:off x="4412520" y="3009960"/>
              <a:ext cx="3179160" cy="2541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3" name="TextBox 40"/>
            <p:cNvSpPr/>
            <p:nvPr/>
          </p:nvSpPr>
          <p:spPr>
            <a:xfrm>
              <a:off x="4548600" y="4249080"/>
              <a:ext cx="526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L-</a:t>
              </a:r>
              <a:r>
                <a:rPr b="1" lang="el-G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β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84" name="Picture 41" descr=""/>
            <p:cNvPicPr/>
            <p:nvPr/>
          </p:nvPicPr>
          <p:blipFill>
            <a:blip r:embed="rId6"/>
            <a:srcRect l="27972" t="26166" r="11856" b="18193"/>
            <a:stretch/>
          </p:blipFill>
          <p:spPr>
            <a:xfrm>
              <a:off x="7444440" y="3334320"/>
              <a:ext cx="3272760" cy="1773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5" name="TextBox 42"/>
            <p:cNvSpPr/>
            <p:nvPr/>
          </p:nvSpPr>
          <p:spPr>
            <a:xfrm>
              <a:off x="7061040" y="4193640"/>
              <a:ext cx="637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β-actin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文本框 7"/>
            <p:cNvSpPr/>
            <p:nvPr/>
          </p:nvSpPr>
          <p:spPr>
            <a:xfrm rot="19380000">
              <a:off x="2747160" y="1487160"/>
              <a:ext cx="636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Control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文本框 8"/>
            <p:cNvSpPr/>
            <p:nvPr/>
          </p:nvSpPr>
          <p:spPr>
            <a:xfrm rot="19380000">
              <a:off x="3126240" y="1592280"/>
              <a:ext cx="412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LP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文本框 9"/>
            <p:cNvSpPr/>
            <p:nvPr/>
          </p:nvSpPr>
          <p:spPr>
            <a:xfrm rot="19380000">
              <a:off x="3363840" y="1554120"/>
              <a:ext cx="538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Allici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文本框 7"/>
            <p:cNvSpPr/>
            <p:nvPr/>
          </p:nvSpPr>
          <p:spPr>
            <a:xfrm rot="19380000">
              <a:off x="5758200" y="1681200"/>
              <a:ext cx="636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Control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文本框 8"/>
            <p:cNvSpPr/>
            <p:nvPr/>
          </p:nvSpPr>
          <p:spPr>
            <a:xfrm rot="19380000">
              <a:off x="6017040" y="1786320"/>
              <a:ext cx="412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LP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文本框 9"/>
            <p:cNvSpPr/>
            <p:nvPr/>
          </p:nvSpPr>
          <p:spPr>
            <a:xfrm rot="19380000">
              <a:off x="6254640" y="1748160"/>
              <a:ext cx="538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Allici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文本框 7"/>
            <p:cNvSpPr/>
            <p:nvPr/>
          </p:nvSpPr>
          <p:spPr>
            <a:xfrm rot="19380000">
              <a:off x="8603280" y="1330200"/>
              <a:ext cx="636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Control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文本框 8"/>
            <p:cNvSpPr/>
            <p:nvPr/>
          </p:nvSpPr>
          <p:spPr>
            <a:xfrm rot="19380000">
              <a:off x="8861760" y="1435320"/>
              <a:ext cx="412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LP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文本框 9"/>
            <p:cNvSpPr/>
            <p:nvPr/>
          </p:nvSpPr>
          <p:spPr>
            <a:xfrm rot="19380000">
              <a:off x="9136440" y="1397160"/>
              <a:ext cx="538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Allici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文本框 7"/>
            <p:cNvSpPr/>
            <p:nvPr/>
          </p:nvSpPr>
          <p:spPr>
            <a:xfrm rot="19380000">
              <a:off x="2655000" y="3824640"/>
              <a:ext cx="636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Control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文本框 8"/>
            <p:cNvSpPr/>
            <p:nvPr/>
          </p:nvSpPr>
          <p:spPr>
            <a:xfrm rot="19380000">
              <a:off x="2969280" y="3902040"/>
              <a:ext cx="412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LP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文本框 9"/>
            <p:cNvSpPr/>
            <p:nvPr/>
          </p:nvSpPr>
          <p:spPr>
            <a:xfrm rot="19380000">
              <a:off x="3252960" y="3863880"/>
              <a:ext cx="538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Allici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文本框 7"/>
            <p:cNvSpPr/>
            <p:nvPr/>
          </p:nvSpPr>
          <p:spPr>
            <a:xfrm rot="19380000">
              <a:off x="5425920" y="4009320"/>
              <a:ext cx="636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Control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文本框 8"/>
            <p:cNvSpPr/>
            <p:nvPr/>
          </p:nvSpPr>
          <p:spPr>
            <a:xfrm rot="19380000">
              <a:off x="5776920" y="4114440"/>
              <a:ext cx="412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LP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文本框 9"/>
            <p:cNvSpPr/>
            <p:nvPr/>
          </p:nvSpPr>
          <p:spPr>
            <a:xfrm rot="19380000">
              <a:off x="6079320" y="4076280"/>
              <a:ext cx="538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Allici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文本框 7"/>
            <p:cNvSpPr/>
            <p:nvPr/>
          </p:nvSpPr>
          <p:spPr>
            <a:xfrm rot="19380000">
              <a:off x="8602920" y="3658320"/>
              <a:ext cx="636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Control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文本框 8"/>
            <p:cNvSpPr/>
            <p:nvPr/>
          </p:nvSpPr>
          <p:spPr>
            <a:xfrm rot="19380000">
              <a:off x="9046440" y="3763440"/>
              <a:ext cx="412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LP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文本框 9"/>
            <p:cNvSpPr/>
            <p:nvPr/>
          </p:nvSpPr>
          <p:spPr>
            <a:xfrm rot="19380000">
              <a:off x="9367560" y="3725280"/>
              <a:ext cx="538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Allici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Rectangle 3"/>
          <p:cNvSpPr/>
          <p:nvPr/>
        </p:nvSpPr>
        <p:spPr>
          <a:xfrm>
            <a:off x="81000" y="85680"/>
            <a:ext cx="2014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Supplementary Informat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Rectangle 4"/>
          <p:cNvSpPr/>
          <p:nvPr/>
        </p:nvSpPr>
        <p:spPr>
          <a:xfrm>
            <a:off x="65160" y="436680"/>
            <a:ext cx="5800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Figure 5.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(A)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presentative original western blot images of transfected with Nrf2 siRNA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06" name="Group 7"/>
          <p:cNvGrpSpPr/>
          <p:nvPr/>
        </p:nvGrpSpPr>
        <p:grpSpPr>
          <a:xfrm>
            <a:off x="3699000" y="841320"/>
            <a:ext cx="5730840" cy="1717560"/>
            <a:chOff x="3699000" y="841320"/>
            <a:chExt cx="5730840" cy="1717560"/>
          </a:xfrm>
        </p:grpSpPr>
        <p:pic>
          <p:nvPicPr>
            <p:cNvPr id="107" name="Picture 5" descr=""/>
            <p:cNvPicPr/>
            <p:nvPr/>
          </p:nvPicPr>
          <p:blipFill>
            <a:blip r:embed="rId1"/>
            <a:srcRect l="16141" t="8149" r="11713" b="12003"/>
            <a:stretch/>
          </p:blipFill>
          <p:spPr>
            <a:xfrm>
              <a:off x="4137840" y="933480"/>
              <a:ext cx="2262600" cy="1625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8" name="TextBox 62"/>
            <p:cNvSpPr/>
            <p:nvPr/>
          </p:nvSpPr>
          <p:spPr>
            <a:xfrm>
              <a:off x="3699000" y="1607760"/>
              <a:ext cx="526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rf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09" name="Picture 6" descr=""/>
            <p:cNvPicPr/>
            <p:nvPr/>
          </p:nvPicPr>
          <p:blipFill>
            <a:blip r:embed="rId2"/>
            <a:srcRect l="15440" t="11302" r="6735" b="10384"/>
            <a:stretch/>
          </p:blipFill>
          <p:spPr>
            <a:xfrm>
              <a:off x="6871680" y="841320"/>
              <a:ext cx="2558160" cy="1717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0" name="TextBox 63"/>
            <p:cNvSpPr/>
            <p:nvPr/>
          </p:nvSpPr>
          <p:spPr>
            <a:xfrm>
              <a:off x="6506640" y="1616760"/>
              <a:ext cx="637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β-actin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文本框 23"/>
            <p:cNvSpPr/>
            <p:nvPr/>
          </p:nvSpPr>
          <p:spPr>
            <a:xfrm rot="19380000">
              <a:off x="5028840" y="1040400"/>
              <a:ext cx="685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Control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文本框 24"/>
            <p:cNvSpPr/>
            <p:nvPr/>
          </p:nvSpPr>
          <p:spPr>
            <a:xfrm rot="19380000">
              <a:off x="5325120" y="1145160"/>
              <a:ext cx="532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 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siNC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文本框 25"/>
            <p:cNvSpPr/>
            <p:nvPr/>
          </p:nvSpPr>
          <p:spPr>
            <a:xfrm rot="19380000">
              <a:off x="5598000" y="1107720"/>
              <a:ext cx="569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siNrf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文本框 23"/>
            <p:cNvSpPr/>
            <p:nvPr/>
          </p:nvSpPr>
          <p:spPr>
            <a:xfrm rot="19380000">
              <a:off x="7822800" y="1220760"/>
              <a:ext cx="685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Control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文本框 24"/>
            <p:cNvSpPr/>
            <p:nvPr/>
          </p:nvSpPr>
          <p:spPr>
            <a:xfrm rot="19380000">
              <a:off x="8155800" y="1325520"/>
              <a:ext cx="532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 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siNC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文本框 25"/>
            <p:cNvSpPr/>
            <p:nvPr/>
          </p:nvSpPr>
          <p:spPr>
            <a:xfrm rot="19380000">
              <a:off x="8465760" y="1288080"/>
              <a:ext cx="569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siNrf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17" name="Rectangle 70"/>
          <p:cNvSpPr/>
          <p:nvPr/>
        </p:nvSpPr>
        <p:spPr>
          <a:xfrm>
            <a:off x="60480" y="2916360"/>
            <a:ext cx="539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Figure 5.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(D)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presentative original western blot images of HO-1 and NLRP3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18" name="Group 11"/>
          <p:cNvGrpSpPr/>
          <p:nvPr/>
        </p:nvGrpSpPr>
        <p:grpSpPr>
          <a:xfrm>
            <a:off x="1386000" y="3638520"/>
            <a:ext cx="9512280" cy="2303640"/>
            <a:chOff x="1386000" y="3638520"/>
            <a:chExt cx="9512280" cy="2303640"/>
          </a:xfrm>
        </p:grpSpPr>
        <p:pic>
          <p:nvPicPr>
            <p:cNvPr id="119" name="Picture 8" descr=""/>
            <p:cNvPicPr/>
            <p:nvPr/>
          </p:nvPicPr>
          <p:blipFill>
            <a:blip r:embed="rId3"/>
            <a:srcRect l="13623" t="0" r="6942" b="0"/>
            <a:stretch/>
          </p:blipFill>
          <p:spPr>
            <a:xfrm>
              <a:off x="5199840" y="4037760"/>
              <a:ext cx="2742840" cy="1904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0" name="TextBox 71"/>
            <p:cNvSpPr/>
            <p:nvPr/>
          </p:nvSpPr>
          <p:spPr>
            <a:xfrm>
              <a:off x="1386000" y="4655160"/>
              <a:ext cx="701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LRP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21" name="Picture 9" descr=""/>
            <p:cNvPicPr/>
            <p:nvPr/>
          </p:nvPicPr>
          <p:blipFill>
            <a:blip r:embed="rId4"/>
            <a:srcRect l="7965" t="26013" r="13615" b="14091"/>
            <a:stretch/>
          </p:blipFill>
          <p:spPr>
            <a:xfrm>
              <a:off x="2013480" y="4249440"/>
              <a:ext cx="2512080" cy="1440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2" name="TextBox 72"/>
            <p:cNvSpPr/>
            <p:nvPr/>
          </p:nvSpPr>
          <p:spPr>
            <a:xfrm>
              <a:off x="4682520" y="4650480"/>
              <a:ext cx="637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O-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23" name="Picture 10" descr=""/>
            <p:cNvPicPr/>
            <p:nvPr/>
          </p:nvPicPr>
          <p:blipFill>
            <a:blip r:embed="rId5"/>
            <a:srcRect l="12364" t="7719" r="12090" b="14589"/>
            <a:stretch/>
          </p:blipFill>
          <p:spPr>
            <a:xfrm>
              <a:off x="8321760" y="4063680"/>
              <a:ext cx="2576520" cy="1515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4" name="TextBox 73"/>
            <p:cNvSpPr/>
            <p:nvPr/>
          </p:nvSpPr>
          <p:spPr>
            <a:xfrm>
              <a:off x="7850520" y="4733640"/>
              <a:ext cx="637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β-actin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125" name="Group 74"/>
            <p:cNvGrpSpPr/>
            <p:nvPr/>
          </p:nvGrpSpPr>
          <p:grpSpPr>
            <a:xfrm>
              <a:off x="1707480" y="3661560"/>
              <a:ext cx="1797840" cy="616320"/>
              <a:chOff x="1707480" y="3661560"/>
              <a:chExt cx="1797840" cy="616320"/>
            </a:xfrm>
          </p:grpSpPr>
          <p:sp>
            <p:nvSpPr>
              <p:cNvPr id="126" name="文本框 1"/>
              <p:cNvSpPr/>
              <p:nvPr/>
            </p:nvSpPr>
            <p:spPr>
              <a:xfrm>
                <a:off x="2375640" y="3661920"/>
                <a:ext cx="11073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2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➖    ➖     ➕  ➕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7" name="文本框 2"/>
              <p:cNvSpPr/>
              <p:nvPr/>
            </p:nvSpPr>
            <p:spPr>
              <a:xfrm>
                <a:off x="2397960" y="4001400"/>
                <a:ext cx="11073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2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➖   ➕     ➖   ➕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8" name="文本框 18"/>
              <p:cNvSpPr/>
              <p:nvPr/>
            </p:nvSpPr>
            <p:spPr>
              <a:xfrm>
                <a:off x="1707480" y="3661560"/>
                <a:ext cx="604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宋体"/>
                  </a:rPr>
                  <a:t>Allicin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9" name="文本框 18"/>
              <p:cNvSpPr/>
              <p:nvPr/>
            </p:nvSpPr>
            <p:spPr>
              <a:xfrm>
                <a:off x="1726560" y="4000680"/>
                <a:ext cx="5695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宋体"/>
                  </a:rPr>
                  <a:t>siNrf2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30" name="Group 79"/>
            <p:cNvGrpSpPr/>
            <p:nvPr/>
          </p:nvGrpSpPr>
          <p:grpSpPr>
            <a:xfrm>
              <a:off x="5332680" y="3638520"/>
              <a:ext cx="1797840" cy="616320"/>
              <a:chOff x="5332680" y="3638520"/>
              <a:chExt cx="1797840" cy="616320"/>
            </a:xfrm>
          </p:grpSpPr>
          <p:sp>
            <p:nvSpPr>
              <p:cNvPr id="131" name="文本框 1"/>
              <p:cNvSpPr/>
              <p:nvPr/>
            </p:nvSpPr>
            <p:spPr>
              <a:xfrm>
                <a:off x="6000840" y="3638880"/>
                <a:ext cx="11073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2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➖    ➖     ➕  ➕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2" name="文本框 2"/>
              <p:cNvSpPr/>
              <p:nvPr/>
            </p:nvSpPr>
            <p:spPr>
              <a:xfrm>
                <a:off x="6023160" y="3978360"/>
                <a:ext cx="11073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2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➖   ➕     ➖   ➕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3" name="文本框 18"/>
              <p:cNvSpPr/>
              <p:nvPr/>
            </p:nvSpPr>
            <p:spPr>
              <a:xfrm>
                <a:off x="5332680" y="3638520"/>
                <a:ext cx="604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宋体"/>
                  </a:rPr>
                  <a:t>Allicin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4" name="文本框 18"/>
              <p:cNvSpPr/>
              <p:nvPr/>
            </p:nvSpPr>
            <p:spPr>
              <a:xfrm>
                <a:off x="5351760" y="3977640"/>
                <a:ext cx="5695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宋体"/>
                  </a:rPr>
                  <a:t>siNrf2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35" name="Group 84"/>
            <p:cNvGrpSpPr/>
            <p:nvPr/>
          </p:nvGrpSpPr>
          <p:grpSpPr>
            <a:xfrm>
              <a:off x="8343360" y="3656880"/>
              <a:ext cx="1797840" cy="616320"/>
              <a:chOff x="8343360" y="3656880"/>
              <a:chExt cx="1797840" cy="616320"/>
            </a:xfrm>
          </p:grpSpPr>
          <p:sp>
            <p:nvSpPr>
              <p:cNvPr id="136" name="文本框 1"/>
              <p:cNvSpPr/>
              <p:nvPr/>
            </p:nvSpPr>
            <p:spPr>
              <a:xfrm>
                <a:off x="9011520" y="3657240"/>
                <a:ext cx="11073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2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➖    ➖     ➕  ➕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7" name="文本框 2"/>
              <p:cNvSpPr/>
              <p:nvPr/>
            </p:nvSpPr>
            <p:spPr>
              <a:xfrm>
                <a:off x="9033840" y="3996720"/>
                <a:ext cx="11073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2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➖   ➕     ➖   ➕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8" name="文本框 18"/>
              <p:cNvSpPr/>
              <p:nvPr/>
            </p:nvSpPr>
            <p:spPr>
              <a:xfrm>
                <a:off x="8343360" y="3656880"/>
                <a:ext cx="604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宋体"/>
                  </a:rPr>
                  <a:t>Allicin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9" name="文本框 18"/>
              <p:cNvSpPr/>
              <p:nvPr/>
            </p:nvSpPr>
            <p:spPr>
              <a:xfrm>
                <a:off x="8362440" y="3996000"/>
                <a:ext cx="5695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宋体"/>
                  </a:rPr>
                  <a:t>siNrf2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3-07-21T11:13:57Z</dcterms:created>
  <dc:creator>Zhihua Wang</dc:creator>
  <dc:description/>
  <dc:language>en-US</dc:language>
  <cp:lastModifiedBy>Zhihua Wang</cp:lastModifiedBy>
  <dcterms:modified xsi:type="dcterms:W3CDTF">2023-07-21T12:07:34Z</dcterms:modified>
  <cp:revision>13</cp:revision>
  <dc:subject/>
  <dc:title>PowerPoint Presentation</dc:title>
</cp:coreProperties>
</file>